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4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49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432" y="114"/>
      </p:cViewPr>
      <p:guideLst>
        <p:guide orient="horz" pos="2160"/>
        <p:guide pos="49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A1F9113-3B71-491D-922C-07F41F2191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4A6D6FE-C47C-4D59-A1C6-0E28475740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90C01D4-2401-4619-BC22-F022E3FD9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B76453D-6FB7-4C37-8F83-3C4CB90BF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FFE7639-1A67-4C2C-B848-3073A89FD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7682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134D257-B47E-47EB-973A-F958697283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D3F4CF1-ABB4-4A11-B700-7E7B974819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7C859C9-6AFD-4845-852E-E083D4B1B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A7537B9-90BF-4F66-BB7C-901B31A0F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3BEDAF9-5324-4257-B948-64CF74714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9991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0F6319C-F3F3-439D-A35E-14F0000EAC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11C82B5-3641-4F78-918D-7452979A17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C11128C-1AEA-44CB-9DE8-26947B4ACA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00F5482-A424-4A7D-A73E-44BADD4179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015F70B-863E-4CD7-BC36-0DE59F212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95873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76222EA-6E80-4ADC-8419-CCA41DDF8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B4D2932-DE2D-4037-8552-E830E06375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4ECDF80-387F-45EC-A2FE-189E1C812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C25A07A-D2CC-4E75-A4A8-53119DE96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7371BE7-ACD0-4B35-B2DD-4B24AACB3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8716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A2E9DC-3DAF-4B49-AE0C-8E82A20EF2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05CFB6A-C972-4947-AF9B-449365A574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107485C-5D2E-437B-81B4-9887C1BE0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6AB8183-C336-4AC3-85BE-C7B50F9D4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20DF940-4071-4C79-AC0B-D385F3A72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7882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9459AC8-43CA-42E7-BDCD-9E186AE5B7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990DCE0-0E35-4938-891A-A27FB6595E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6E44667-854B-448B-A4E5-4F9723B301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3AC7C9E-FB41-4ABE-8A60-B6DD8378B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76950CC-1264-4241-B151-B5CAD8B4C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5B03ADF-82F2-463E-A0E7-C4432E740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0489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426A091-2A63-4565-A86C-960F725FC0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9666215-F60C-4EF2-869B-312DDFBD3C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9289EDE-90FA-4742-BD3F-94606164AC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4532937-C695-43E6-A19E-A94644A242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E36D2A0-F6CC-4A2E-9418-72D4197D34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5BB9C1C-37B9-4297-8075-641A6B18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0E98076-87A4-4734-897A-C32865108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006ADEC3-2DF7-4322-999F-A7A97B1A7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1253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A608B08-2674-4D88-B434-3284663EB6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4850926-8C79-4E43-86B7-9370AE48B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63BBA00-0029-49EB-A352-582EA98D1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7717000-E1D1-462B-ADAF-8C4D6EA1FB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780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9888389B-44A4-4935-B069-13E1EC9D0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3A2D9D5-BD46-45C6-A577-426CC4247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1DE205F-BE34-406B-868C-0845CC46F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8523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EC9A9A8-7301-4DC6-AA44-92F53FD5CB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4F35ED7-96F5-41A6-B679-9A47EA0834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D6FF656-09E9-4111-B341-126B8FED8E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641EE83-517E-4952-BFE1-97CAC3E24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07AEA70-A944-437D-88FE-861961FEF8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A27A30D-2C87-4045-A9F5-62645BEBF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696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3A302EE-73EA-40B5-8A37-66EAE1A7CA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DD609ACF-D84A-4754-BBA5-00841D69D4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187D900-8B4D-4BCC-8AF9-2C32C6ED99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233E3A5-330A-4233-BF53-2F794E576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F2AEAEB-F5C4-4B78-A164-8F7F3F9466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26FD4E5-365D-4739-AD2C-EBF0B7136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6241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4B097301-4EED-4E21-8763-D8476B40B7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23920F8-B94F-4D85-9F4D-84C0365AD9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1064517-9BA4-48BC-B108-9D303D3084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B02A8-8C68-4322-90C6-D3418CC180E2}" type="datetimeFigureOut">
              <a:rPr lang="it-IT" smtClean="0"/>
              <a:t>13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779165C-95E0-4054-B9FE-80CBE63C39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D7A793A-C909-4D5C-8E6A-98BF5E12E1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8695A-19C8-4876-ADC9-795440F164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0091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o 18">
            <a:extLst>
              <a:ext uri="{FF2B5EF4-FFF2-40B4-BE49-F238E27FC236}">
                <a16:creationId xmlns:a16="http://schemas.microsoft.com/office/drawing/2014/main" id="{BF6CFC19-EB1D-4D48-A5A0-D2F13F071EC1}"/>
              </a:ext>
            </a:extLst>
          </p:cNvPr>
          <p:cNvGrpSpPr>
            <a:grpSpLocks noChangeAspect="1"/>
          </p:cNvGrpSpPr>
          <p:nvPr/>
        </p:nvGrpSpPr>
        <p:grpSpPr>
          <a:xfrm>
            <a:off x="3655431" y="1726251"/>
            <a:ext cx="295847" cy="295656"/>
            <a:chOff x="6707273" y="465874"/>
            <a:chExt cx="290482" cy="228785"/>
          </a:xfrm>
        </p:grpSpPr>
        <p:cxnSp>
          <p:nvCxnSpPr>
            <p:cNvPr id="23" name="Connettore diritto 22">
              <a:extLst>
                <a:ext uri="{FF2B5EF4-FFF2-40B4-BE49-F238E27FC236}">
                  <a16:creationId xmlns:a16="http://schemas.microsoft.com/office/drawing/2014/main" id="{F4745ECA-B38E-45B6-809B-9B35950FD193}"/>
                </a:ext>
              </a:extLst>
            </p:cNvPr>
            <p:cNvCxnSpPr/>
            <p:nvPr/>
          </p:nvCxnSpPr>
          <p:spPr>
            <a:xfrm flipH="1">
              <a:off x="6892824" y="472018"/>
              <a:ext cx="977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ttore diritto 23">
              <a:extLst>
                <a:ext uri="{FF2B5EF4-FFF2-40B4-BE49-F238E27FC236}">
                  <a16:creationId xmlns:a16="http://schemas.microsoft.com/office/drawing/2014/main" id="{5EFF54C5-E6FA-4EBB-A018-8157351BBDCB}"/>
                </a:ext>
              </a:extLst>
            </p:cNvPr>
            <p:cNvCxnSpPr/>
            <p:nvPr/>
          </p:nvCxnSpPr>
          <p:spPr>
            <a:xfrm flipH="1">
              <a:off x="6899989" y="694659"/>
              <a:ext cx="977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ttore diritto 24">
              <a:extLst>
                <a:ext uri="{FF2B5EF4-FFF2-40B4-BE49-F238E27FC236}">
                  <a16:creationId xmlns:a16="http://schemas.microsoft.com/office/drawing/2014/main" id="{183BEBFB-9273-49DF-BE86-043318E91448}"/>
                </a:ext>
              </a:extLst>
            </p:cNvPr>
            <p:cNvCxnSpPr/>
            <p:nvPr/>
          </p:nvCxnSpPr>
          <p:spPr>
            <a:xfrm>
              <a:off x="6895693" y="473553"/>
              <a:ext cx="0" cy="2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8071A6E1-1F01-446E-9252-13B94E20B490}"/>
                </a:ext>
              </a:extLst>
            </p:cNvPr>
            <p:cNvSpPr txBox="1"/>
            <p:nvPr/>
          </p:nvSpPr>
          <p:spPr>
            <a:xfrm rot="16200000">
              <a:off x="6723425" y="449722"/>
              <a:ext cx="2139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*</a:t>
              </a:r>
            </a:p>
          </p:txBody>
        </p:sp>
      </p:grp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2B7BAD61-FEE4-4743-92E0-F5939EB8E249}"/>
              </a:ext>
            </a:extLst>
          </p:cNvPr>
          <p:cNvSpPr txBox="1"/>
          <p:nvPr/>
        </p:nvSpPr>
        <p:spPr>
          <a:xfrm rot="16200000">
            <a:off x="-404435" y="2305066"/>
            <a:ext cx="23373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Time to First Treatment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6288E85F-7289-43FA-829A-51D4B51EC907}"/>
              </a:ext>
            </a:extLst>
          </p:cNvPr>
          <p:cNvSpPr txBox="1"/>
          <p:nvPr/>
        </p:nvSpPr>
        <p:spPr>
          <a:xfrm>
            <a:off x="1195746" y="3796687"/>
            <a:ext cx="3221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72A2BCE8-0EC4-4DD9-8BFB-E5728181B19B}"/>
              </a:ext>
            </a:extLst>
          </p:cNvPr>
          <p:cNvSpPr txBox="1"/>
          <p:nvPr/>
        </p:nvSpPr>
        <p:spPr>
          <a:xfrm>
            <a:off x="551224" y="758505"/>
            <a:ext cx="430386" cy="429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8772AB7D-6909-42A1-B74B-8C1A2AF77E16}"/>
              </a:ext>
            </a:extLst>
          </p:cNvPr>
          <p:cNvGrpSpPr>
            <a:grpSpLocks noChangeAspect="1"/>
          </p:cNvGrpSpPr>
          <p:nvPr/>
        </p:nvGrpSpPr>
        <p:grpSpPr>
          <a:xfrm>
            <a:off x="6643300" y="833061"/>
            <a:ext cx="3569199" cy="3144661"/>
            <a:chOff x="6059752" y="1272501"/>
            <a:chExt cx="2712326" cy="2389709"/>
          </a:xfrm>
        </p:grpSpPr>
        <p:grpSp>
          <p:nvGrpSpPr>
            <p:cNvPr id="29" name="Gruppo 28">
              <a:extLst>
                <a:ext uri="{FF2B5EF4-FFF2-40B4-BE49-F238E27FC236}">
                  <a16:creationId xmlns:a16="http://schemas.microsoft.com/office/drawing/2014/main" id="{CC5D87D1-0097-41E5-B3BA-8CB18589786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059752" y="1501821"/>
              <a:ext cx="2712326" cy="2160389"/>
              <a:chOff x="3863907" y="2912292"/>
              <a:chExt cx="2823850" cy="2249225"/>
            </a:xfrm>
          </p:grpSpPr>
          <p:grpSp>
            <p:nvGrpSpPr>
              <p:cNvPr id="31" name="Gruppo 30">
                <a:extLst>
                  <a:ext uri="{FF2B5EF4-FFF2-40B4-BE49-F238E27FC236}">
                    <a16:creationId xmlns:a16="http://schemas.microsoft.com/office/drawing/2014/main" id="{B5528657-874D-472F-9E38-0EE899B74536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863907" y="2912292"/>
                <a:ext cx="2142639" cy="2039812"/>
                <a:chOff x="3398341" y="3508612"/>
                <a:chExt cx="2039408" cy="1941537"/>
              </a:xfrm>
            </p:grpSpPr>
            <p:grpSp>
              <p:nvGrpSpPr>
                <p:cNvPr id="34" name="Gruppo 33">
                  <a:extLst>
                    <a:ext uri="{FF2B5EF4-FFF2-40B4-BE49-F238E27FC236}">
                      <a16:creationId xmlns:a16="http://schemas.microsoft.com/office/drawing/2014/main" id="{516542FC-6D38-4734-9A6B-D47496549978}"/>
                    </a:ext>
                  </a:extLst>
                </p:cNvPr>
                <p:cNvGrpSpPr/>
                <p:nvPr/>
              </p:nvGrpSpPr>
              <p:grpSpPr>
                <a:xfrm>
                  <a:off x="4951806" y="3614511"/>
                  <a:ext cx="485943" cy="549693"/>
                  <a:chOff x="4942281" y="3624036"/>
                  <a:chExt cx="485943" cy="549693"/>
                </a:xfrm>
              </p:grpSpPr>
              <p:cxnSp>
                <p:nvCxnSpPr>
                  <p:cNvPr id="36" name="Connettore diritto 35">
                    <a:extLst>
                      <a:ext uri="{FF2B5EF4-FFF2-40B4-BE49-F238E27FC236}">
                        <a16:creationId xmlns:a16="http://schemas.microsoft.com/office/drawing/2014/main" id="{6BB06045-C8F6-400F-9C4F-CD89039AC548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5326332" y="3635105"/>
                    <a:ext cx="977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Connettore diritto 36">
                    <a:extLst>
                      <a:ext uri="{FF2B5EF4-FFF2-40B4-BE49-F238E27FC236}">
                        <a16:creationId xmlns:a16="http://schemas.microsoft.com/office/drawing/2014/main" id="{159D4914-EDAC-4303-BA30-6FF606A191E1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5328633" y="3854437"/>
                    <a:ext cx="977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Connettore diritto 37">
                    <a:extLst>
                      <a:ext uri="{FF2B5EF4-FFF2-40B4-BE49-F238E27FC236}">
                        <a16:creationId xmlns:a16="http://schemas.microsoft.com/office/drawing/2014/main" id="{40865F68-2BCA-416D-AB3E-1E27AC3E0DAD}"/>
                      </a:ext>
                    </a:extLst>
                  </p:cNvPr>
                  <p:cNvCxnSpPr/>
                  <p:nvPr/>
                </p:nvCxnSpPr>
                <p:spPr>
                  <a:xfrm>
                    <a:off x="5324337" y="3636640"/>
                    <a:ext cx="0" cy="216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9" name="CasellaDiTesto 38">
                    <a:extLst>
                      <a:ext uri="{FF2B5EF4-FFF2-40B4-BE49-F238E27FC236}">
                        <a16:creationId xmlns:a16="http://schemas.microsoft.com/office/drawing/2014/main" id="{665E327C-ADD5-4656-94C5-115736298B6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186896" y="3624250"/>
                    <a:ext cx="21391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000" dirty="0"/>
                      <a:t>*</a:t>
                    </a:r>
                  </a:p>
                </p:txBody>
              </p:sp>
              <p:cxnSp>
                <p:nvCxnSpPr>
                  <p:cNvPr id="40" name="Connettore diritto 39">
                    <a:extLst>
                      <a:ext uri="{FF2B5EF4-FFF2-40B4-BE49-F238E27FC236}">
                        <a16:creationId xmlns:a16="http://schemas.microsoft.com/office/drawing/2014/main" id="{F6970231-55E3-4954-AE72-E32B287F1A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134212" y="3630314"/>
                    <a:ext cx="977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Connettore diritto 40">
                    <a:extLst>
                      <a:ext uri="{FF2B5EF4-FFF2-40B4-BE49-F238E27FC236}">
                        <a16:creationId xmlns:a16="http://schemas.microsoft.com/office/drawing/2014/main" id="{3F2B131C-0F42-48C0-A554-F89B76E754C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132841" y="4080636"/>
                    <a:ext cx="977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Connettore diritto 41">
                    <a:extLst>
                      <a:ext uri="{FF2B5EF4-FFF2-40B4-BE49-F238E27FC236}">
                        <a16:creationId xmlns:a16="http://schemas.microsoft.com/office/drawing/2014/main" id="{7A0459E9-1687-4A44-AA31-58EDA10EFAD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128545" y="3631849"/>
                    <a:ext cx="0" cy="450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3" name="CasellaDiTesto 42">
                    <a:extLst>
                      <a:ext uri="{FF2B5EF4-FFF2-40B4-BE49-F238E27FC236}">
                        <a16:creationId xmlns:a16="http://schemas.microsoft.com/office/drawing/2014/main" id="{A0B63375-5A9F-4E6A-8054-2117128D011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836442" y="3729875"/>
                    <a:ext cx="45789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000" dirty="0"/>
                      <a:t>*</a:t>
                    </a:r>
                  </a:p>
                </p:txBody>
              </p:sp>
              <p:cxnSp>
                <p:nvCxnSpPr>
                  <p:cNvPr id="44" name="Connettore diritto 43">
                    <a:extLst>
                      <a:ext uri="{FF2B5EF4-FFF2-40B4-BE49-F238E27FC236}">
                        <a16:creationId xmlns:a16="http://schemas.microsoft.com/office/drawing/2014/main" id="{9F82AEC0-3C79-4A7E-8ADE-2EBDA2D3237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328157" y="3874742"/>
                    <a:ext cx="977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Connettore diritto 44">
                    <a:extLst>
                      <a:ext uri="{FF2B5EF4-FFF2-40B4-BE49-F238E27FC236}">
                        <a16:creationId xmlns:a16="http://schemas.microsoft.com/office/drawing/2014/main" id="{D8215DDE-F6AB-46CE-A29F-84ABD6853D1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330458" y="4083420"/>
                    <a:ext cx="977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Connettore diritto 45">
                    <a:extLst>
                      <a:ext uri="{FF2B5EF4-FFF2-40B4-BE49-F238E27FC236}">
                        <a16:creationId xmlns:a16="http://schemas.microsoft.com/office/drawing/2014/main" id="{B5765453-BE6D-4392-829D-7098B679FE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331199" y="3869658"/>
                    <a:ext cx="0" cy="216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7" name="CasellaDiTesto 46">
                    <a:extLst>
                      <a:ext uri="{FF2B5EF4-FFF2-40B4-BE49-F238E27FC236}">
                        <a16:creationId xmlns:a16="http://schemas.microsoft.com/office/drawing/2014/main" id="{E9BD34EE-9320-42BA-9473-CD9FF60B603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063459" y="3853084"/>
                    <a:ext cx="39506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000" dirty="0" err="1"/>
                      <a:t>n.s.</a:t>
                    </a:r>
                    <a:endParaRPr lang="it-IT" sz="1000" dirty="0"/>
                  </a:p>
                </p:txBody>
              </p:sp>
            </p:grpSp>
            <p:sp>
              <p:nvSpPr>
                <p:cNvPr id="35" name="CasellaDiTesto 34">
                  <a:extLst>
                    <a:ext uri="{FF2B5EF4-FFF2-40B4-BE49-F238E27FC236}">
                      <a16:creationId xmlns:a16="http://schemas.microsoft.com/office/drawing/2014/main" id="{40F6AB8F-B675-4A63-B1BD-C80A6BDE631E}"/>
                    </a:ext>
                  </a:extLst>
                </p:cNvPr>
                <p:cNvSpPr txBox="1"/>
                <p:nvPr/>
              </p:nvSpPr>
              <p:spPr>
                <a:xfrm rot="16200000">
                  <a:off x="2543459" y="4363494"/>
                  <a:ext cx="1941537" cy="2317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ime to First Treatment</a:t>
                  </a:r>
                </a:p>
              </p:txBody>
            </p:sp>
          </p:grpSp>
          <p:sp>
            <p:nvSpPr>
              <p:cNvPr id="32" name="CasellaDiTesto 31">
                <a:extLst>
                  <a:ext uri="{FF2B5EF4-FFF2-40B4-BE49-F238E27FC236}">
                    <a16:creationId xmlns:a16="http://schemas.microsoft.com/office/drawing/2014/main" id="{BF7BC3D2-4F20-4095-A2EA-AD406DFFD4BD}"/>
                  </a:ext>
                </a:extLst>
              </p:cNvPr>
              <p:cNvSpPr txBox="1"/>
              <p:nvPr/>
            </p:nvSpPr>
            <p:spPr>
              <a:xfrm>
                <a:off x="5105141" y="4918011"/>
                <a:ext cx="1582616" cy="2435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</a:t>
                </a:r>
                <a:r>
                  <a:rPr lang="it-IT" sz="1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onths</a:t>
                </a:r>
                <a:r>
                  <a:rPr lang="it-IT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FABBDB13-857C-49A5-B946-90B751FB4AAC}"/>
                </a:ext>
              </a:extLst>
            </p:cNvPr>
            <p:cNvSpPr txBox="1"/>
            <p:nvPr/>
          </p:nvSpPr>
          <p:spPr>
            <a:xfrm>
              <a:off x="6238802" y="1272501"/>
              <a:ext cx="370525" cy="369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/>
                <a:t>B</a:t>
              </a:r>
            </a:p>
          </p:txBody>
        </p:sp>
      </p:grp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328AA130-67D8-48C8-86FE-D9BB18EBD510}"/>
              </a:ext>
            </a:extLst>
          </p:cNvPr>
          <p:cNvSpPr txBox="1"/>
          <p:nvPr/>
        </p:nvSpPr>
        <p:spPr>
          <a:xfrm>
            <a:off x="8923867" y="6434667"/>
            <a:ext cx="3268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3</a:t>
            </a:r>
          </a:p>
        </p:txBody>
      </p:sp>
      <p:graphicFrame>
        <p:nvGraphicFramePr>
          <p:cNvPr id="8" name="Oggetto 7">
            <a:extLst>
              <a:ext uri="{FF2B5EF4-FFF2-40B4-BE49-F238E27FC236}">
                <a16:creationId xmlns:a16="http://schemas.microsoft.com/office/drawing/2014/main" id="{9F9C7F99-DBF5-4E6B-85AD-E9BD7650BA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3100671"/>
              </p:ext>
            </p:extLst>
          </p:nvPr>
        </p:nvGraphicFramePr>
        <p:xfrm>
          <a:off x="6791325" y="933450"/>
          <a:ext cx="4308475" cy="2957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3590553" imgH="2463814" progId="Prism8.Document">
                  <p:embed/>
                </p:oleObj>
              </mc:Choice>
              <mc:Fallback>
                <p:oleObj name="Prism 8" r:id="rId3" imgW="3590553" imgH="24638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91325" y="933450"/>
                        <a:ext cx="4308475" cy="2957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ggetto 8">
            <a:extLst>
              <a:ext uri="{FF2B5EF4-FFF2-40B4-BE49-F238E27FC236}">
                <a16:creationId xmlns:a16="http://schemas.microsoft.com/office/drawing/2014/main" id="{CF5B5D1C-74EE-4951-B66B-217533590E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6712135"/>
              </p:ext>
            </p:extLst>
          </p:nvPr>
        </p:nvGraphicFramePr>
        <p:xfrm>
          <a:off x="809248" y="989986"/>
          <a:ext cx="4272758" cy="29319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5" imgW="3590553" imgH="2463814" progId="Prism8.Document">
                  <p:embed/>
                </p:oleObj>
              </mc:Choice>
              <mc:Fallback>
                <p:oleObj name="Prism 8" r:id="rId5" imgW="3590553" imgH="24638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09248" y="989986"/>
                        <a:ext cx="4272758" cy="29319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334227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53</TotalTime>
  <Words>26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8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 Baldoni</dc:creator>
  <cp:lastModifiedBy>Reparto</cp:lastModifiedBy>
  <cp:revision>19</cp:revision>
  <dcterms:created xsi:type="dcterms:W3CDTF">2021-03-05T13:31:55Z</dcterms:created>
  <dcterms:modified xsi:type="dcterms:W3CDTF">2021-04-13T13:32:06Z</dcterms:modified>
</cp:coreProperties>
</file>